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3"/>
  </p:sldMasterIdLst>
  <p:notesMasterIdLst>
    <p:notesMasterId r:id="rId15"/>
  </p:notesMasterIdLst>
  <p:handoutMasterIdLst>
    <p:handoutMasterId r:id="rId16"/>
  </p:handoutMasterIdLst>
  <p:sldIdLst>
    <p:sldId id="378" r:id="rId4"/>
    <p:sldId id="371" r:id="rId5"/>
    <p:sldId id="354" r:id="rId6"/>
    <p:sldId id="366" r:id="rId7"/>
    <p:sldId id="361" r:id="rId8"/>
    <p:sldId id="360" r:id="rId9"/>
    <p:sldId id="359" r:id="rId10"/>
    <p:sldId id="362" r:id="rId11"/>
    <p:sldId id="377" r:id="rId12"/>
    <p:sldId id="373" r:id="rId13"/>
    <p:sldId id="372" r:id="rId1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BEBEBE"/>
    <a:srgbClr val="8EB4E2"/>
    <a:srgbClr val="008FFF"/>
    <a:srgbClr val="FF2800"/>
    <a:srgbClr val="385F92"/>
    <a:srgbClr val="3760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6598" autoAdjust="0"/>
    <p:restoredTop sz="97884"/>
  </p:normalViewPr>
  <p:slideViewPr>
    <p:cSldViewPr snapToGrid="0" snapToObjects="1">
      <p:cViewPr>
        <p:scale>
          <a:sx n="169" d="100"/>
          <a:sy n="169" d="100"/>
        </p:scale>
        <p:origin x="192" y="-2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1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7.xml"/><Relationship Id="rId19" Type="http://schemas.openxmlformats.org/officeDocument/2006/relationships/theme" Target="theme/theme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slide" Target="slides/slide1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28E329-ACE2-42D1-A911-32B72A0E4F42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37F7CD-7D32-42A8-8FB5-001F5FB8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7723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746F80-154B-6E46-875E-37D4913CAE39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EAE3B6-E4E5-E74F-BA7D-84F55683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588770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AE3B6-E4E5-E74F-BA7D-84F556833F3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6347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AE3B6-E4E5-E74F-BA7D-84F556833F3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4053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AE3B6-E4E5-E74F-BA7D-84F556833F3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022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770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11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346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23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989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15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377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898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339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081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69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0279B-1925-7942-8AC7-C701A9B99646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91DBDA-8563-264C-86B9-499595854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607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4" name="Picture 163">
            <a:extLst>
              <a:ext uri="{FF2B5EF4-FFF2-40B4-BE49-F238E27FC236}">
                <a16:creationId xmlns:a16="http://schemas.microsoft.com/office/drawing/2014/main" id="{B8AE066B-BA48-CA4A-B4A5-E96F2B9410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98021"/>
            <a:ext cx="6858000" cy="3990109"/>
          </a:xfrm>
          <a:prstGeom prst="rect">
            <a:avLst/>
          </a:prstGeom>
        </p:spPr>
      </p:pic>
      <p:sp>
        <p:nvSpPr>
          <p:cNvPr id="165" name="TextBox 164">
            <a:extLst>
              <a:ext uri="{FF2B5EF4-FFF2-40B4-BE49-F238E27FC236}">
                <a16:creationId xmlns:a16="http://schemas.microsoft.com/office/drawing/2014/main" id="{F038D3F1-17A2-1246-8405-88D68DB15136}"/>
              </a:ext>
            </a:extLst>
          </p:cNvPr>
          <p:cNvSpPr txBox="1"/>
          <p:nvPr/>
        </p:nvSpPr>
        <p:spPr>
          <a:xfrm>
            <a:off x="0" y="0"/>
            <a:ext cx="94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1</a:t>
            </a:r>
          </a:p>
        </p:txBody>
      </p:sp>
    </p:spTree>
    <p:extLst>
      <p:ext uri="{BB962C8B-B14F-4D97-AF65-F5344CB8AC3E}">
        <p14:creationId xmlns:p14="http://schemas.microsoft.com/office/powerpoint/2010/main" val="12843305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0F3EC6E-164D-FF43-8742-FA8F9301A5B6}"/>
              </a:ext>
            </a:extLst>
          </p:cNvPr>
          <p:cNvSpPr txBox="1"/>
          <p:nvPr/>
        </p:nvSpPr>
        <p:spPr>
          <a:xfrm>
            <a:off x="1119561" y="568655"/>
            <a:ext cx="12763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BB2-amp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9AE0DA-804F-AF42-B769-DDF5864D72FD}"/>
              </a:ext>
            </a:extLst>
          </p:cNvPr>
          <p:cNvSpPr txBox="1"/>
          <p:nvPr/>
        </p:nvSpPr>
        <p:spPr>
          <a:xfrm>
            <a:off x="4671841" y="568655"/>
            <a:ext cx="926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umina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DBF8E4-7213-9D4D-B3EB-DA39032975EA}"/>
              </a:ext>
            </a:extLst>
          </p:cNvPr>
          <p:cNvSpPr txBox="1"/>
          <p:nvPr/>
        </p:nvSpPr>
        <p:spPr>
          <a:xfrm>
            <a:off x="631103" y="4253469"/>
            <a:ext cx="24071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asal and Claudin - low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367B832-8E11-784C-9279-1D49C3F4C9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803" y="4622801"/>
            <a:ext cx="3429000" cy="323410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9F8E8B0-C207-0B49-89E1-24980364AA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340" y="1057194"/>
            <a:ext cx="3188660" cy="288126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6BBEB13-519E-A049-990A-E018C0A0D8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47318" y="4657379"/>
            <a:ext cx="1568985" cy="198084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D407484-6099-3247-A5E9-532CF53FD3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40940" y="1057194"/>
            <a:ext cx="3188660" cy="303445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11F6406-A28F-2240-9740-0B165A002064}"/>
              </a:ext>
            </a:extLst>
          </p:cNvPr>
          <p:cNvSpPr txBox="1"/>
          <p:nvPr/>
        </p:nvSpPr>
        <p:spPr>
          <a:xfrm>
            <a:off x="0" y="0"/>
            <a:ext cx="1458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 Figure 5B</a:t>
            </a:r>
          </a:p>
        </p:txBody>
      </p:sp>
    </p:spTree>
    <p:extLst>
      <p:ext uri="{BB962C8B-B14F-4D97-AF65-F5344CB8AC3E}">
        <p14:creationId xmlns:p14="http://schemas.microsoft.com/office/powerpoint/2010/main" val="39966442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2922565-E8E0-3C41-87BD-37CBAB2F02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69039"/>
            <a:ext cx="6858000" cy="175221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160C265-4AD2-C742-B8AF-E23F789B3C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285458"/>
            <a:ext cx="6858000" cy="172895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2C5ACDF-D7A7-4A4E-9233-50960D71AB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346326"/>
            <a:ext cx="6858000" cy="172462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EC6C769-A98B-FC46-AB55-1DD9DEBF6212}"/>
              </a:ext>
            </a:extLst>
          </p:cNvPr>
          <p:cNvSpPr txBox="1"/>
          <p:nvPr/>
        </p:nvSpPr>
        <p:spPr>
          <a:xfrm>
            <a:off x="0" y="0"/>
            <a:ext cx="1458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 Figure 5C</a:t>
            </a:r>
          </a:p>
        </p:txBody>
      </p:sp>
    </p:spTree>
    <p:extLst>
      <p:ext uri="{BB962C8B-B14F-4D97-AF65-F5344CB8AC3E}">
        <p14:creationId xmlns:p14="http://schemas.microsoft.com/office/powerpoint/2010/main" val="1395385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0DC38E0-2185-2847-80B6-A5F029B41D07}"/>
              </a:ext>
            </a:extLst>
          </p:cNvPr>
          <p:cNvSpPr txBox="1"/>
          <p:nvPr/>
        </p:nvSpPr>
        <p:spPr>
          <a:xfrm>
            <a:off x="0" y="0"/>
            <a:ext cx="94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B3FBD4-FCBD-8940-B75D-687D6CA56D29}"/>
              </a:ext>
            </a:extLst>
          </p:cNvPr>
          <p:cNvSpPr txBox="1"/>
          <p:nvPr/>
        </p:nvSpPr>
        <p:spPr>
          <a:xfrm>
            <a:off x="4677294" y="1636639"/>
            <a:ext cx="323165" cy="52354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900" b="1" dirty="0"/>
              <a:t>Sensitiv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07128E0-017C-7F48-8FB7-0BB852DE3F87}"/>
              </a:ext>
            </a:extLst>
          </p:cNvPr>
          <p:cNvSpPr txBox="1"/>
          <p:nvPr/>
        </p:nvSpPr>
        <p:spPr>
          <a:xfrm>
            <a:off x="4692683" y="2602580"/>
            <a:ext cx="323165" cy="53796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900" b="1" dirty="0"/>
              <a:t>Resistant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581E45D6-BBEC-D749-A967-3107B270E1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393" t="5306" r="34762" b="7634"/>
          <a:stretch/>
        </p:blipFill>
        <p:spPr>
          <a:xfrm>
            <a:off x="219329" y="1130130"/>
            <a:ext cx="4337665" cy="670202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34CD02D-3F06-CF49-AD73-2486C020D60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103" t="12978" r="13454" b="13448"/>
          <a:stretch/>
        </p:blipFill>
        <p:spPr>
          <a:xfrm>
            <a:off x="4948671" y="1586399"/>
            <a:ext cx="1870132" cy="6245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5854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985157" y="573087"/>
            <a:ext cx="1012372" cy="5551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66840" y="1411149"/>
            <a:ext cx="1663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C6E807E-22CB-5D4B-885C-C3992D96E000}"/>
              </a:ext>
            </a:extLst>
          </p:cNvPr>
          <p:cNvSpPr txBox="1"/>
          <p:nvPr/>
        </p:nvSpPr>
        <p:spPr>
          <a:xfrm>
            <a:off x="66840" y="43740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4CA221-48FD-5440-BBB0-F93F317BD6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40" y="806736"/>
            <a:ext cx="6368902" cy="254119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D70A3D6-92D3-3242-BE6B-C31738B79DD4}"/>
              </a:ext>
            </a:extLst>
          </p:cNvPr>
          <p:cNvSpPr txBox="1"/>
          <p:nvPr/>
        </p:nvSpPr>
        <p:spPr>
          <a:xfrm>
            <a:off x="0" y="0"/>
            <a:ext cx="94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8B47D0A-75F0-4143-B065-A229552016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435607"/>
            <a:ext cx="6858000" cy="570839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3895530-3CEB-4341-80FF-C77C77207CA4}"/>
              </a:ext>
            </a:extLst>
          </p:cNvPr>
          <p:cNvSpPr txBox="1"/>
          <p:nvPr/>
        </p:nvSpPr>
        <p:spPr>
          <a:xfrm>
            <a:off x="63152" y="333832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560068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56FDC86-04B6-E44C-88B2-5D482150E3A2}"/>
              </a:ext>
            </a:extLst>
          </p:cNvPr>
          <p:cNvSpPr txBox="1"/>
          <p:nvPr/>
        </p:nvSpPr>
        <p:spPr>
          <a:xfrm>
            <a:off x="204801" y="4365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0C8DB4D-4163-6942-A99C-F3FB6BE6B27A}"/>
              </a:ext>
            </a:extLst>
          </p:cNvPr>
          <p:cNvSpPr txBox="1"/>
          <p:nvPr/>
        </p:nvSpPr>
        <p:spPr>
          <a:xfrm>
            <a:off x="212817" y="483819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3D14656-B530-4A48-8813-B8EF938C4B9D}"/>
              </a:ext>
            </a:extLst>
          </p:cNvPr>
          <p:cNvSpPr txBox="1"/>
          <p:nvPr/>
        </p:nvSpPr>
        <p:spPr>
          <a:xfrm>
            <a:off x="0" y="0"/>
            <a:ext cx="94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8383B91-1BE8-E84F-93D1-E7FED5DD20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47838" y="960686"/>
            <a:ext cx="1210162" cy="54351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D2CBEF3-58D9-7D4D-8DC3-FECDB123E26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9" t="-1" b="1132"/>
          <a:stretch/>
        </p:blipFill>
        <p:spPr>
          <a:xfrm>
            <a:off x="147022" y="901405"/>
            <a:ext cx="5456042" cy="367059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6FA2825-B5B7-F249-B8D0-B5F8DC6974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01698" y="5022858"/>
            <a:ext cx="1568985" cy="198084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8E11195-68C9-094D-94AC-C3D9A9D447C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168" t="8232" r="38594" b="11484"/>
          <a:stretch/>
        </p:blipFill>
        <p:spPr>
          <a:xfrm>
            <a:off x="702240" y="5022858"/>
            <a:ext cx="3788228" cy="3670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4747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D9D55A8-CC18-2443-BBC4-6B8210AE83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471750"/>
            <a:ext cx="6858000" cy="22005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FF6F67-F5FF-FB4F-A24C-9448AE8D5DD1}"/>
              </a:ext>
            </a:extLst>
          </p:cNvPr>
          <p:cNvSpPr txBox="1"/>
          <p:nvPr/>
        </p:nvSpPr>
        <p:spPr>
          <a:xfrm>
            <a:off x="0" y="0"/>
            <a:ext cx="1683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 Figure 1</a:t>
            </a:r>
          </a:p>
        </p:txBody>
      </p:sp>
    </p:spTree>
    <p:extLst>
      <p:ext uri="{BB962C8B-B14F-4D97-AF65-F5344CB8AC3E}">
        <p14:creationId xmlns:p14="http://schemas.microsoft.com/office/powerpoint/2010/main" val="19461696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BF9BE73-75DE-C645-AB7B-8F95FDA9DA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4777" y="1103104"/>
            <a:ext cx="6028660" cy="804089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0C6C6E0-912B-BD44-AE70-11B4709C651D}"/>
              </a:ext>
            </a:extLst>
          </p:cNvPr>
          <p:cNvSpPr txBox="1"/>
          <p:nvPr/>
        </p:nvSpPr>
        <p:spPr>
          <a:xfrm>
            <a:off x="247061" y="5918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3874D84-9914-7348-AE0D-528F4B282132}"/>
              </a:ext>
            </a:extLst>
          </p:cNvPr>
          <p:cNvSpPr txBox="1"/>
          <p:nvPr/>
        </p:nvSpPr>
        <p:spPr>
          <a:xfrm>
            <a:off x="255077" y="356815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206ADB4-FE90-2D4F-9043-FACB3B7181D1}"/>
              </a:ext>
            </a:extLst>
          </p:cNvPr>
          <p:cNvSpPr txBox="1"/>
          <p:nvPr/>
        </p:nvSpPr>
        <p:spPr>
          <a:xfrm>
            <a:off x="0" y="0"/>
            <a:ext cx="1458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 Figure 2</a:t>
            </a:r>
          </a:p>
        </p:txBody>
      </p:sp>
    </p:spTree>
    <p:extLst>
      <p:ext uri="{BB962C8B-B14F-4D97-AF65-F5344CB8AC3E}">
        <p14:creationId xmlns:p14="http://schemas.microsoft.com/office/powerpoint/2010/main" val="38520222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A28C0FE-FC08-0A46-828C-94FD251E2A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634" y="1221234"/>
            <a:ext cx="6858000" cy="317368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CB6E1F4-20F8-4E4C-BEE7-5D5488B86859}"/>
              </a:ext>
            </a:extLst>
          </p:cNvPr>
          <p:cNvSpPr txBox="1"/>
          <p:nvPr/>
        </p:nvSpPr>
        <p:spPr>
          <a:xfrm>
            <a:off x="0" y="0"/>
            <a:ext cx="1458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 Figure 3</a:t>
            </a:r>
          </a:p>
        </p:txBody>
      </p:sp>
    </p:spTree>
    <p:extLst>
      <p:ext uri="{BB962C8B-B14F-4D97-AF65-F5344CB8AC3E}">
        <p14:creationId xmlns:p14="http://schemas.microsoft.com/office/powerpoint/2010/main" val="12035004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985157" y="573087"/>
            <a:ext cx="1012372" cy="5551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66840" y="1411149"/>
            <a:ext cx="1663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4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7162682-A205-BE4A-B0F0-52938613F6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597446"/>
            <a:ext cx="6858000" cy="594910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C8DFAB9-AC08-C34F-86A5-46BAD633B406}"/>
              </a:ext>
            </a:extLst>
          </p:cNvPr>
          <p:cNvSpPr txBox="1"/>
          <p:nvPr/>
        </p:nvSpPr>
        <p:spPr>
          <a:xfrm>
            <a:off x="0" y="0"/>
            <a:ext cx="1400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 Figure 4</a:t>
            </a:r>
          </a:p>
        </p:txBody>
      </p:sp>
    </p:spTree>
    <p:extLst>
      <p:ext uri="{BB962C8B-B14F-4D97-AF65-F5344CB8AC3E}">
        <p14:creationId xmlns:p14="http://schemas.microsoft.com/office/powerpoint/2010/main" val="27343413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09265F-D32E-1544-9059-4A98628337EB}"/>
              </a:ext>
            </a:extLst>
          </p:cNvPr>
          <p:cNvSpPr txBox="1"/>
          <p:nvPr/>
        </p:nvSpPr>
        <p:spPr>
          <a:xfrm>
            <a:off x="491279" y="1632344"/>
            <a:ext cx="1592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uminal (n=17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F8C9107-9D1C-594B-83CA-2783A93C4A36}"/>
              </a:ext>
            </a:extLst>
          </p:cNvPr>
          <p:cNvSpPr txBox="1"/>
          <p:nvPr/>
        </p:nvSpPr>
        <p:spPr>
          <a:xfrm>
            <a:off x="2463053" y="1556409"/>
            <a:ext cx="19415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asal or Claudin-low (n=18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1F70D82-38C4-DE46-8665-48E1C059E794}"/>
              </a:ext>
            </a:extLst>
          </p:cNvPr>
          <p:cNvSpPr txBox="1"/>
          <p:nvPr/>
        </p:nvSpPr>
        <p:spPr>
          <a:xfrm>
            <a:off x="4690335" y="1601155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BB2-amp (n=10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B39A0A-AF57-CB44-8C57-4E72486835D6}"/>
              </a:ext>
            </a:extLst>
          </p:cNvPr>
          <p:cNvSpPr txBox="1"/>
          <p:nvPr/>
        </p:nvSpPr>
        <p:spPr>
          <a:xfrm>
            <a:off x="386558" y="4988174"/>
            <a:ext cx="50263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ltered: only agents with at least one association (</a:t>
            </a:r>
            <a:r>
              <a:rPr lang="en-US" u="sng" dirty="0"/>
              <a:t>BH corrected</a:t>
            </a:r>
            <a:r>
              <a:rPr lang="en-US" dirty="0"/>
              <a:t> p&lt;0.05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43866B0-4930-AA44-927C-BE395E99E996}"/>
              </a:ext>
            </a:extLst>
          </p:cNvPr>
          <p:cNvSpPr txBox="1"/>
          <p:nvPr/>
        </p:nvSpPr>
        <p:spPr>
          <a:xfrm>
            <a:off x="417914" y="727856"/>
            <a:ext cx="52431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ltered: only agents with at least one association (</a:t>
            </a:r>
            <a:r>
              <a:rPr lang="en-US" u="sng" dirty="0"/>
              <a:t>uncorrected</a:t>
            </a:r>
            <a:r>
              <a:rPr lang="en-US" dirty="0"/>
              <a:t> p&lt;0.05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EA8F2C1-7E54-954E-8BFD-E1D380D2B985}"/>
              </a:ext>
            </a:extLst>
          </p:cNvPr>
          <p:cNvSpPr txBox="1"/>
          <p:nvPr/>
        </p:nvSpPr>
        <p:spPr>
          <a:xfrm>
            <a:off x="746788" y="5826044"/>
            <a:ext cx="1592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uminal (n=17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FDD90FF-A209-E04E-B647-CE60854C9F46}"/>
              </a:ext>
            </a:extLst>
          </p:cNvPr>
          <p:cNvSpPr txBox="1"/>
          <p:nvPr/>
        </p:nvSpPr>
        <p:spPr>
          <a:xfrm>
            <a:off x="2899716" y="5814568"/>
            <a:ext cx="27613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asal or Claudin-low (n=18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2BB638E-47A2-1C47-9A0A-9B8D8D572B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279" y="6395311"/>
            <a:ext cx="1906793" cy="190679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514C359-EBE2-4847-A0C7-B992A9DA0F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30950" y="6289532"/>
            <a:ext cx="2231136" cy="223113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4A3BBF09-947B-274D-8F97-B739896477F9}"/>
              </a:ext>
            </a:extLst>
          </p:cNvPr>
          <p:cNvSpPr txBox="1"/>
          <p:nvPr/>
        </p:nvSpPr>
        <p:spPr>
          <a:xfrm>
            <a:off x="484095" y="8430404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og(OR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8A31C3D-00CF-8D42-9366-DB4CA2CAC3CF}"/>
              </a:ext>
            </a:extLst>
          </p:cNvPr>
          <p:cNvSpPr txBox="1"/>
          <p:nvPr/>
        </p:nvSpPr>
        <p:spPr>
          <a:xfrm>
            <a:off x="2899716" y="856890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og(OR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B67669B-56C9-4E4E-85D7-DCB5B55CF880}"/>
              </a:ext>
            </a:extLst>
          </p:cNvPr>
          <p:cNvSpPr txBox="1"/>
          <p:nvPr/>
        </p:nvSpPr>
        <p:spPr>
          <a:xfrm>
            <a:off x="0" y="0"/>
            <a:ext cx="1458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I Figure 5A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8D5CDDF1-AD44-9E43-8791-4D40BCA7CE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6745" y="2318236"/>
            <a:ext cx="2194560" cy="219456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AB59E02C-5D26-6F40-A0BB-D355C0A01E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63440" y="2250501"/>
            <a:ext cx="2194560" cy="219456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D707D00-733C-AC47-B7AF-172A1875A0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050" y="2250501"/>
            <a:ext cx="2194560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8637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
</file>

<file path=customXml/item2.xml><?xml version="1.0" encoding="utf-8"?>
<sisl xmlns:xsi="http://www.w3.org/2001/XMLSchema-instance" xmlns:xsd="http://www.w3.org/2001/XMLSchema" xmlns="http://www.boldonjames.com/2008/01/sie/internal/label" sislVersion="0" policy="82ad3a63-90ad-4a46-a3cb-757f4658e205" origin="userSelected">
  <element uid="ba0343df-3220-4244-9388-1298e2abc028" value=""/>
  <element uid="1772ffb8-6792-4a8e-935d-5610926e7efa" value=""/>
  <element uid="7349a702-6462-4442-88eb-c64cd513835c" value=""/>
</sisl>
</file>

<file path=customXml/itemProps1.xml><?xml version="1.0" encoding="utf-8"?>
<ds:datastoreItem xmlns:ds="http://schemas.openxmlformats.org/officeDocument/2006/customXml" ds:itemID="{34EA5604-3C6E-4D00-9C7A-F3F062E3DEDD}">
  <ds:schemaRefs>
    <ds:schemaRef ds:uri="http://www.w3.org/2001/XMLSchema"/>
    <ds:schemaRef ds:uri="http://www.boldonjames.com/2008/01/sie/internal/label"/>
  </ds:schemaRefs>
</ds:datastoreItem>
</file>

<file path=customXml/itemProps2.xml><?xml version="1.0" encoding="utf-8"?>
<ds:datastoreItem xmlns:ds="http://schemas.openxmlformats.org/officeDocument/2006/customXml" ds:itemID="{AB1C3EC8-B0C7-4215-993A-094204C2D4DB}">
  <ds:schemaRefs>
    <ds:schemaRef ds:uri="http://www.w3.org/2001/XMLSchema"/>
    <ds:schemaRef ds:uri="http://www.boldonjames.com/2008/01/sie/internal/label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7083</TotalTime>
  <Words>120</Words>
  <Application>Microsoft Macintosh PowerPoint</Application>
  <PresentationFormat>Letter Paper (8.5x11 in)</PresentationFormat>
  <Paragraphs>34</Paragraphs>
  <Slides>11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ksandra Olow</dc:creator>
  <cp:keywords>*$%CON-*$%PersonalInfo</cp:keywords>
  <cp:lastModifiedBy>Olow, Ola</cp:lastModifiedBy>
  <cp:revision>210</cp:revision>
  <cp:lastPrinted>2017-10-20T04:30:54Z</cp:lastPrinted>
  <dcterms:created xsi:type="dcterms:W3CDTF">2016-04-27T20:23:29Z</dcterms:created>
  <dcterms:modified xsi:type="dcterms:W3CDTF">2020-12-24T07:41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IndexRef">
    <vt:lpwstr>a17ff90f-3ee2-4af2-aa78-287ef53845f7</vt:lpwstr>
  </property>
  <property fmtid="{D5CDD505-2E9C-101B-9397-08002B2CF9AE}" pid="3" name="bjSaver">
    <vt:lpwstr>VKgBjDx7dE3SZOaB+swAa/50JXphHAd1</vt:lpwstr>
  </property>
  <property fmtid="{D5CDD505-2E9C-101B-9397-08002B2CF9AE}" pid="4" name="bjDocumentLabelXML">
    <vt:lpwstr>&lt;?xml version="1.0" encoding="us-ascii"?&gt;&lt;sisl xmlns:xsi="http://www.w3.org/2001/XMLSchema-instance" xmlns:xsd="http://www.w3.org/2001/XMLSchema" sislVersion="0" policy="82ad3a63-90ad-4a46-a3cb-757f4658e205" origin="userSelected" xmlns="http://www.boldonj</vt:lpwstr>
  </property>
  <property fmtid="{D5CDD505-2E9C-101B-9397-08002B2CF9AE}" pid="5" name="bjDocumentLabelXML-0">
    <vt:lpwstr>ames.com/2008/01/sie/internal/label"&gt;&lt;element uid="ba0343df-3220-4244-9388-1298e2abc028" value="" /&gt;&lt;element uid="1772ffb8-6792-4a8e-935d-5610926e7efa" value="" /&gt;&lt;element uid="7349a702-6462-4442-88eb-c64cd513835c" value="" /&gt;&lt;/sisl&gt;</vt:lpwstr>
  </property>
  <property fmtid="{D5CDD505-2E9C-101B-9397-08002B2CF9AE}" pid="6" name="bjDocumentSecurityLabel">
    <vt:lpwstr>Confidential - Personal Information</vt:lpwstr>
  </property>
</Properties>
</file>